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1788" y="7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52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8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28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3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58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6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3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7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74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88" y="-1281496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-1294733"/>
            <a:ext cx="1106405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4607" y="-1281496"/>
            <a:ext cx="1100790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8787" y="-1281496"/>
            <a:ext cx="1100791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9578" y="-1281496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1594" y="-1263134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8394" y="-1281496"/>
            <a:ext cx="1100790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08994" y="-1308854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739146"/>
            <a:ext cx="1109215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0215" y="1739146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6621" y="1739146"/>
            <a:ext cx="1103598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1536" y="1739146"/>
            <a:ext cx="1103598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6" name="Picture 14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5134" y="1758196"/>
            <a:ext cx="1109215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6696" y="1758196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8" name="Picture 16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4406" y="1758196"/>
            <a:ext cx="1103598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8004" y="1758196"/>
            <a:ext cx="110640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0" name="Picture 18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66" y="4665226"/>
            <a:ext cx="1131680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1" name="Picture 19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2719" y="4656082"/>
            <a:ext cx="112887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2" name="Picture 20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1591" y="4665226"/>
            <a:ext cx="1126063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3" name="Picture 21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4176" y="4665226"/>
            <a:ext cx="1123255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4" name="Picture 22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1920" y="4664434"/>
            <a:ext cx="1131680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5" name="Picture 23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4680466"/>
            <a:ext cx="112887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6" name="Picture 24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0" y="4680466"/>
            <a:ext cx="1123255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7" name="Picture 25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78403" y="4634746"/>
            <a:ext cx="112887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8" name="Picture 26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201" y="7567132"/>
            <a:ext cx="114291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9" name="Picture 27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4741" y="7567132"/>
            <a:ext cx="114291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1" name="Picture 29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5974" y="7567132"/>
            <a:ext cx="113729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2" name="Picture 30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4601" y="7567132"/>
            <a:ext cx="113729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3" name="Picture 31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7551366"/>
            <a:ext cx="114291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4" name="Picture 32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7552684"/>
            <a:ext cx="114291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5" name="Picture 33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9904" y="7546111"/>
            <a:ext cx="1137296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6" name="Picture 34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51498" y="7530346"/>
            <a:ext cx="1142912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743761" y="-1676400"/>
            <a:ext cx="8208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VNPK            VNP.</a:t>
            </a:r>
            <a:r>
              <a:rPr lang="en-US" b="1" dirty="0" smtClean="0">
                <a:solidFill>
                  <a:srgbClr val="FF0000"/>
                </a:solidFill>
              </a:rPr>
              <a:t>N</a:t>
            </a:r>
            <a:r>
              <a:rPr lang="en-US" b="1" dirty="0" smtClean="0"/>
              <a:t>        AKFK            AK</a:t>
            </a:r>
            <a:r>
              <a:rPr lang="en-US" b="1" dirty="0" smtClean="0">
                <a:solidFill>
                  <a:srgbClr val="FF0000"/>
                </a:solidFill>
              </a:rPr>
              <a:t>C</a:t>
            </a:r>
            <a:r>
              <a:rPr lang="en-US" b="1" dirty="0" smtClean="0"/>
              <a:t>K           FVQG          FVQ.</a:t>
            </a:r>
            <a:r>
              <a:rPr lang="en-US" b="1" dirty="0" smtClean="0">
                <a:solidFill>
                  <a:srgbClr val="FF0000"/>
                </a:solidFill>
              </a:rPr>
              <a:t>V</a:t>
            </a:r>
            <a:r>
              <a:rPr lang="en-US" b="1" dirty="0" smtClean="0"/>
              <a:t>         LADE          SLAS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-1554490" y="-273899"/>
            <a:ext cx="1478290" cy="94487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UcParenR"/>
            </a:pPr>
            <a:r>
              <a:rPr lang="en-US" sz="3200" b="1" dirty="0" smtClean="0"/>
              <a:t> WT</a:t>
            </a:r>
          </a:p>
          <a:p>
            <a:pPr marL="342900" indent="-342900">
              <a:buAutoNum type="alphaUcParenR"/>
            </a:pPr>
            <a:endParaRPr lang="en-US" sz="3200" b="1" dirty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r>
              <a:rPr lang="en-US" sz="3200" b="1" dirty="0" smtClean="0"/>
              <a:t> Y87</a:t>
            </a:r>
            <a:endParaRPr lang="en-US" sz="3200" b="1" dirty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r>
              <a:rPr lang="en-US" sz="3200" b="1" dirty="0" smtClean="0"/>
              <a:t> F102</a:t>
            </a:r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endParaRPr lang="en-US" sz="3200" b="1" dirty="0" smtClean="0"/>
          </a:p>
          <a:p>
            <a:pPr marL="342900" indent="-342900">
              <a:buAutoNum type="alphaUcParenR"/>
            </a:pPr>
            <a:r>
              <a:rPr lang="en-US" sz="3200" b="1" dirty="0"/>
              <a:t> </a:t>
            </a:r>
            <a:r>
              <a:rPr lang="en-US" sz="3200" b="1" dirty="0" smtClean="0"/>
              <a:t>F133</a:t>
            </a:r>
            <a:endParaRPr lang="en-US" sz="3200" b="1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-5384757" y="4139821"/>
            <a:ext cx="11138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eavy 	    Light		Heavy 	      Light		Heavy 	          Light	      Heavy 	Ligh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047151" y="-1147777"/>
            <a:ext cx="6182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.D		   N.D		           N.D	     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970657" y="1771844"/>
            <a:ext cx="6182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.D		        	        N.D		               N.D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2187593" y="4680466"/>
            <a:ext cx="6182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.D	 N.D		                             N.D	     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2133600" y="7607195"/>
            <a:ext cx="6182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.D	                        N.D	    N.D	  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7842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4</TotalTime>
  <Words>21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PNN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ntification of Mutant SPOP Proteins in Prostate Cancer Using Mass Spectrometry-Based Targeted Proteomics</dc:title>
  <dc:creator>test</dc:creator>
  <cp:lastModifiedBy>Liu, Tao</cp:lastModifiedBy>
  <cp:revision>19</cp:revision>
  <dcterms:created xsi:type="dcterms:W3CDTF">2017-05-12T18:52:21Z</dcterms:created>
  <dcterms:modified xsi:type="dcterms:W3CDTF">2017-07-15T07:33:40Z</dcterms:modified>
</cp:coreProperties>
</file>